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410D6-04BB-41E1-A3B8-4DCCF37B869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FA885A-D051-45DC-9BD1-8968E41A64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34768D-6C24-4159-BB4E-16DA130E97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8062D6-0710-4B15-8E08-5174E69089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974016-0095-4D27-8F2D-41103A2E06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A09EE9-6FDA-4157-8DA8-DC2F2CBCC0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3D148-CFA4-4516-84A3-13B3BE2C97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5E1415-EC2F-4BE0-A2C8-3252BD565A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9CCABD-3B93-4A12-81ED-B9DC8EF735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56D04-6491-4F30-AB22-9F9C7D0148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16AE7D-C577-4C03-8EDF-CFEDE84F74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E952B-1BA1-45AB-94F5-9EDAC5C587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10A2C6A-2B36-4263-8ECC-9856A8192404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asellaDiTesto 192"/>
          <p:cNvSpPr/>
          <p:nvPr/>
        </p:nvSpPr>
        <p:spPr>
          <a:xfrm>
            <a:off x="4730760" y="4680"/>
            <a:ext cx="208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CasellaDiTesto 1"/>
          <p:cNvSpPr/>
          <p:nvPr/>
        </p:nvSpPr>
        <p:spPr>
          <a:xfrm>
            <a:off x="728640" y="6253200"/>
            <a:ext cx="483552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4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SP2a deregulation affects GSH metabolism in prostate experimental model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sessment of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GSH content and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) 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CS enzyme activity carried out in both LNCaP and iPrEC cells, displaying different USP2a protein level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CasellaDiTesto 1"/>
          <p:cNvSpPr/>
          <p:nvPr/>
        </p:nvSpPr>
        <p:spPr>
          <a:xfrm>
            <a:off x="858960" y="684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CasellaDiTesto 15"/>
          <p:cNvSpPr/>
          <p:nvPr/>
        </p:nvSpPr>
        <p:spPr>
          <a:xfrm>
            <a:off x="858240" y="2916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" name="Gruppo 1"/>
          <p:cNvGrpSpPr/>
          <p:nvPr/>
        </p:nvGrpSpPr>
        <p:grpSpPr>
          <a:xfrm>
            <a:off x="1324800" y="3062160"/>
            <a:ext cx="3867120" cy="2818080"/>
            <a:chOff x="1324800" y="3062160"/>
            <a:chExt cx="3867120" cy="2818080"/>
          </a:xfrm>
        </p:grpSpPr>
        <p:sp>
          <p:nvSpPr>
            <p:cNvPr id="46" name="CasellaDiTesto 2"/>
            <p:cNvSpPr/>
            <p:nvPr/>
          </p:nvSpPr>
          <p:spPr>
            <a:xfrm>
              <a:off x="1795320" y="3259080"/>
              <a:ext cx="3219840" cy="140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,03610 ± 0,0036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Vector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,0383 ± 0,0031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USP2a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,0847 ± 0,0136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USP2a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MU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,0370 ± 0,006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iControl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,0347 ± 0,0035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iUSP2a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,0257 ± 0,0040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&lt;0,005 pUSP2a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Arial"/>
                </a:rPr>
                <a:t>vs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Vecto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&lt;0,05 siControl 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Arial"/>
                </a:rPr>
                <a:t>vs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siUSP2a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CasellaDiTesto 27"/>
            <p:cNvSpPr/>
            <p:nvPr/>
          </p:nvSpPr>
          <p:spPr>
            <a:xfrm>
              <a:off x="1505160" y="3062160"/>
              <a:ext cx="3394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Experimental model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GCS activity (U/mg protei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Connettore 1 12"/>
            <p:cNvSpPr/>
            <p:nvPr/>
          </p:nvSpPr>
          <p:spPr>
            <a:xfrm>
              <a:off x="1333440" y="3277800"/>
              <a:ext cx="37818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Connettore 1 13"/>
            <p:cNvSpPr/>
            <p:nvPr/>
          </p:nvSpPr>
          <p:spPr>
            <a:xfrm>
              <a:off x="1333440" y="4327560"/>
              <a:ext cx="37818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0" name="Gruppo 7"/>
            <p:cNvGrpSpPr/>
            <p:nvPr/>
          </p:nvGrpSpPr>
          <p:grpSpPr>
            <a:xfrm>
              <a:off x="1333080" y="4748040"/>
              <a:ext cx="3781800" cy="29160"/>
              <a:chOff x="1333080" y="4748040"/>
              <a:chExt cx="3781800" cy="29160"/>
            </a:xfrm>
          </p:grpSpPr>
          <p:sp>
            <p:nvSpPr>
              <p:cNvPr id="51" name="Connettore 1 16"/>
              <p:cNvSpPr/>
              <p:nvPr/>
            </p:nvSpPr>
            <p:spPr>
              <a:xfrm>
                <a:off x="1333080" y="4748040"/>
                <a:ext cx="3781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Connettore 1 17"/>
              <p:cNvSpPr/>
              <p:nvPr/>
            </p:nvSpPr>
            <p:spPr>
              <a:xfrm>
                <a:off x="1333080" y="4777200"/>
                <a:ext cx="3781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3" name="CasellaDiTesto 5"/>
            <p:cNvSpPr/>
            <p:nvPr/>
          </p:nvSpPr>
          <p:spPr>
            <a:xfrm>
              <a:off x="1324800" y="366228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CasellaDiTesto 2"/>
            <p:cNvSpPr/>
            <p:nvPr/>
          </p:nvSpPr>
          <p:spPr>
            <a:xfrm>
              <a:off x="1810440" y="4843080"/>
              <a:ext cx="3381480" cy="1037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Empty vector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,0257 ± 0,007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USP2a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,0453 ± 0,0084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USP2a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MU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,0187 ± 0,003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c 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&lt;0,05 USP2a</a:t>
              </a:r>
              <a:r>
                <a:rPr b="0" lang="en-US" sz="700" spc="-1" strike="noStrike" baseline="30000">
                  <a:solidFill>
                    <a:srgbClr val="000000"/>
                  </a:solidFill>
                  <a:latin typeface="Arial"/>
                </a:rPr>
                <a:t>WT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Arial"/>
                </a:rPr>
                <a:t>vs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empty vector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CasellaDiTesto 23"/>
            <p:cNvSpPr/>
            <p:nvPr/>
          </p:nvSpPr>
          <p:spPr>
            <a:xfrm>
              <a:off x="1387440" y="5100120"/>
              <a:ext cx="44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iPrEC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Connettore 1 24"/>
            <p:cNvSpPr/>
            <p:nvPr/>
          </p:nvSpPr>
          <p:spPr>
            <a:xfrm>
              <a:off x="1333440" y="5569200"/>
              <a:ext cx="37818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7" name="Gruppo 19"/>
          <p:cNvGrpSpPr/>
          <p:nvPr/>
        </p:nvGrpSpPr>
        <p:grpSpPr>
          <a:xfrm>
            <a:off x="1330920" y="890640"/>
            <a:ext cx="3875400" cy="1935720"/>
            <a:chOff x="1330920" y="890640"/>
            <a:chExt cx="3875400" cy="1935720"/>
          </a:xfrm>
        </p:grpSpPr>
        <p:grpSp>
          <p:nvGrpSpPr>
            <p:cNvPr id="58" name="Gruppo 7"/>
            <p:cNvGrpSpPr/>
            <p:nvPr/>
          </p:nvGrpSpPr>
          <p:grpSpPr>
            <a:xfrm>
              <a:off x="1330920" y="890640"/>
              <a:ext cx="3875400" cy="1599120"/>
              <a:chOff x="1330920" y="890640"/>
              <a:chExt cx="3875400" cy="1599120"/>
            </a:xfrm>
          </p:grpSpPr>
          <p:sp>
            <p:nvSpPr>
              <p:cNvPr id="59" name="CasellaDiTesto 2"/>
              <p:cNvSpPr/>
              <p:nvPr/>
            </p:nvSpPr>
            <p:spPr>
              <a:xfrm>
                <a:off x="1550880" y="1087560"/>
                <a:ext cx="3655440" cy="1402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2,7 ± 2,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Vector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1,7 ± 2,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USP2a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WT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9,3 ± 1,5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USP2a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MUT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2,3 ± 5,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siContro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8,7 ± 0,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siUSP2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5,0 ± 2,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lvl="4" marL="2057400" indent="-228600">
                  <a:lnSpc>
                    <a:spcPct val="100000"/>
                  </a:lnSpc>
                  <a:tabLst>
                    <a:tab algn="l" pos="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a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i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&lt;0,05 pUSP2a</a:t>
                </a: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WT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i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s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Vector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lvl="4" marL="2057400" indent="-228600">
                  <a:lnSpc>
                    <a:spcPct val="100000"/>
                  </a:lnSpc>
                  <a:tabLst>
                    <a:tab algn="l" pos="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b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i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&lt;0,05 siControl </a:t>
                </a:r>
                <a:r>
                  <a:rPr b="0" i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s</a:t>
                </a: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siUSP2a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CasellaDiTesto 27"/>
              <p:cNvSpPr/>
              <p:nvPr/>
            </p:nvSpPr>
            <p:spPr>
              <a:xfrm>
                <a:off x="1439640" y="890640"/>
                <a:ext cx="35258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Experimental model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	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GSH content (nmol/mg protein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Connettore 1 6"/>
              <p:cNvSpPr/>
              <p:nvPr/>
            </p:nvSpPr>
            <p:spPr>
              <a:xfrm>
                <a:off x="1330920" y="1106280"/>
                <a:ext cx="3779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Connettore 1 32"/>
              <p:cNvSpPr/>
              <p:nvPr/>
            </p:nvSpPr>
            <p:spPr>
              <a:xfrm>
                <a:off x="1330920" y="2156040"/>
                <a:ext cx="3779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3" name="CasellaDiTesto 28"/>
            <p:cNvSpPr/>
            <p:nvPr/>
          </p:nvSpPr>
          <p:spPr>
            <a:xfrm>
              <a:off x="1334160" y="1508400"/>
              <a:ext cx="508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LNCaP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CasellaDiTesto 2"/>
            <p:cNvSpPr/>
            <p:nvPr/>
          </p:nvSpPr>
          <p:spPr>
            <a:xfrm>
              <a:off x="1796760" y="2625840"/>
              <a:ext cx="20095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7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0" i="1" lang="en-US" sz="7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2T12:49:07Z</dcterms:created>
  <dc:creator>BarbaraB</dc:creator>
  <dc:description/>
  <dc:language>en-US</dc:language>
  <cp:lastModifiedBy>BarbaraB</cp:lastModifiedBy>
  <cp:lastPrinted>2013-05-26T11:07:27Z</cp:lastPrinted>
  <dcterms:modified xsi:type="dcterms:W3CDTF">2013-06-10T13:53:55Z</dcterms:modified>
  <cp:revision>41</cp:revision>
  <dc:subject/>
  <dc:title>Presentazione standard di PowerPoint</dc:title>
</cp:coreProperties>
</file>